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202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5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1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6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0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2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4400" y="762000"/>
            <a:ext cx="30747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2</a:t>
            </a:r>
            <a:r>
              <a:rPr lang="en-US" dirty="0" smtClean="0"/>
              <a:t>-figure supplement 1B 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9623863"/>
              </p:ext>
            </p:extLst>
          </p:nvPr>
        </p:nvGraphicFramePr>
        <p:xfrm>
          <a:off x="1600200" y="1981200"/>
          <a:ext cx="5562599" cy="3238500"/>
        </p:xfrm>
        <a:graphic>
          <a:graphicData uri="http://schemas.openxmlformats.org/drawingml/2006/table">
            <a:tbl>
              <a:tblPr/>
              <a:tblGrid>
                <a:gridCol w="919513">
                  <a:extLst>
                    <a:ext uri="{9D8B030D-6E8A-4147-A177-3AD203B41FA5}">
                      <a16:colId xmlns:a16="http://schemas.microsoft.com/office/drawing/2014/main" xmlns="" val="3540503088"/>
                    </a:ext>
                  </a:extLst>
                </a:gridCol>
                <a:gridCol w="764744">
                  <a:extLst>
                    <a:ext uri="{9D8B030D-6E8A-4147-A177-3AD203B41FA5}">
                      <a16:colId xmlns:a16="http://schemas.microsoft.com/office/drawing/2014/main" xmlns="" val="2423797681"/>
                    </a:ext>
                  </a:extLst>
                </a:gridCol>
                <a:gridCol w="801160">
                  <a:extLst>
                    <a:ext uri="{9D8B030D-6E8A-4147-A177-3AD203B41FA5}">
                      <a16:colId xmlns:a16="http://schemas.microsoft.com/office/drawing/2014/main" xmlns="" val="1187424774"/>
                    </a:ext>
                  </a:extLst>
                </a:gridCol>
                <a:gridCol w="801160">
                  <a:extLst>
                    <a:ext uri="{9D8B030D-6E8A-4147-A177-3AD203B41FA5}">
                      <a16:colId xmlns:a16="http://schemas.microsoft.com/office/drawing/2014/main" xmlns="" val="2286035574"/>
                    </a:ext>
                  </a:extLst>
                </a:gridCol>
                <a:gridCol w="801160">
                  <a:extLst>
                    <a:ext uri="{9D8B030D-6E8A-4147-A177-3AD203B41FA5}">
                      <a16:colId xmlns:a16="http://schemas.microsoft.com/office/drawing/2014/main" xmlns="" val="4021627528"/>
                    </a:ext>
                  </a:extLst>
                </a:gridCol>
                <a:gridCol w="737431">
                  <a:extLst>
                    <a:ext uri="{9D8B030D-6E8A-4147-A177-3AD203B41FA5}">
                      <a16:colId xmlns:a16="http://schemas.microsoft.com/office/drawing/2014/main" xmlns="" val="3156685379"/>
                    </a:ext>
                  </a:extLst>
                </a:gridCol>
                <a:gridCol w="737431">
                  <a:extLst>
                    <a:ext uri="{9D8B030D-6E8A-4147-A177-3AD203B41FA5}">
                      <a16:colId xmlns:a16="http://schemas.microsoft.com/office/drawing/2014/main" xmlns="" val="39934469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Lu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202331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5.212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434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287017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Adrenal gl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4707069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769725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.3240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1151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131100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Bone marrow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2.692304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2942944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2.607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6092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3250469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Bra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7696367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217675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.4359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268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688644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l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0741068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6130253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74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5593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141118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Fetal Bra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8110451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371100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4.322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.0111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091748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Fetal Liv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.5722670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7085173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.7981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8929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699727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r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9.4061499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6942549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5.378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4988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3533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Kidne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6.541301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2853380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95.153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8360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631122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plee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7290344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961364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7.3053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3815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037445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lacent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4.797480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545960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2.269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.848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052703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rostat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8.115878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5376992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638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012536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alivary gl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4.61257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.5112045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7.214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8628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510092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keletal muscle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1097221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1147914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8.0941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5799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845315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pinal cor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8126804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6103370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8.043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921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992958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tomac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1025256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5513214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34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190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284422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Thym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3.453333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101725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8.774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.9377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157452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Thyroid gl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5.808911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.9157757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0.350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9703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601805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mall intesti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2.199697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8381841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6.380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9229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713429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Uter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3.43270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.9182183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0.390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5756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70640717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590800" y="1590097"/>
            <a:ext cx="46618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an         SD              N       Mean     SD              N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3048000" y="1220765"/>
            <a:ext cx="3277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GFL7B                                EGFL7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78326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4400" y="762000"/>
            <a:ext cx="3073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2</a:t>
            </a:r>
            <a:r>
              <a:rPr lang="en-US" dirty="0" smtClean="0"/>
              <a:t>-figure supplement 1C 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2997200" y="2243931"/>
          <a:ext cx="3149600" cy="3238500"/>
        </p:xfrm>
        <a:graphic>
          <a:graphicData uri="http://schemas.openxmlformats.org/drawingml/2006/table">
            <a:tbl>
              <a:tblPr/>
              <a:tblGrid>
                <a:gridCol w="934700">
                  <a:extLst>
                    <a:ext uri="{9D8B030D-6E8A-4147-A177-3AD203B41FA5}">
                      <a16:colId xmlns:a16="http://schemas.microsoft.com/office/drawing/2014/main" xmlns="" val="4283553212"/>
                    </a:ext>
                  </a:extLst>
                </a:gridCol>
                <a:gridCol w="715678">
                  <a:extLst>
                    <a:ext uri="{9D8B030D-6E8A-4147-A177-3AD203B41FA5}">
                      <a16:colId xmlns:a16="http://schemas.microsoft.com/office/drawing/2014/main" xmlns="" val="1501701095"/>
                    </a:ext>
                  </a:extLst>
                </a:gridCol>
                <a:gridCol w="749611">
                  <a:extLst>
                    <a:ext uri="{9D8B030D-6E8A-4147-A177-3AD203B41FA5}">
                      <a16:colId xmlns:a16="http://schemas.microsoft.com/office/drawing/2014/main" xmlns="" val="316019834"/>
                    </a:ext>
                  </a:extLst>
                </a:gridCol>
                <a:gridCol w="749611">
                  <a:extLst>
                    <a:ext uri="{9D8B030D-6E8A-4147-A177-3AD203B41FA5}">
                      <a16:colId xmlns:a16="http://schemas.microsoft.com/office/drawing/2014/main" xmlns="" val="292980074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Lu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13.61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634553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Adrenal gl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.5259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781358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Bone marrow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847.5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159034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Bra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3.074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753497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l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6.739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602371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Fetal Bra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968219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Fetal Liv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4.7777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317927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r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16.86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044249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Kidne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5.474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834641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plee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21.11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910976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lacent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2.636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001535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rostat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.7442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555893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alivary gl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7.3931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881457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keletal muscle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76.848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976166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pinal cor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0.516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67639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tomac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3.74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682124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Thym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1622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361774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Thyroid gl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3.163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400348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mall intesti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4.246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511012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Uter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5.763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72254000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987549" y="1828800"/>
            <a:ext cx="2291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an         SD             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82121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4234807"/>
              </p:ext>
            </p:extLst>
          </p:nvPr>
        </p:nvGraphicFramePr>
        <p:xfrm>
          <a:off x="1371600" y="1447800"/>
          <a:ext cx="6249444" cy="452596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20787">
                  <a:extLst>
                    <a:ext uri="{9D8B030D-6E8A-4147-A177-3AD203B41FA5}">
                      <a16:colId xmlns:a16="http://schemas.microsoft.com/office/drawing/2014/main" xmlns="" val="847315697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1815632619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3756791688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3443553891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4202373520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4212264776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3802500817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2491509953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4095608568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4266374000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2559447603"/>
                    </a:ext>
                  </a:extLst>
                </a:gridCol>
                <a:gridCol w="520787">
                  <a:extLst>
                    <a:ext uri="{9D8B030D-6E8A-4147-A177-3AD203B41FA5}">
                      <a16:colId xmlns:a16="http://schemas.microsoft.com/office/drawing/2014/main" xmlns="" val="649629756"/>
                    </a:ext>
                  </a:extLst>
                </a:gridCol>
              </a:tblGrid>
              <a:tr h="294570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ycle valu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ycle valu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900" u="none" strike="noStrike">
                          <a:effectLst/>
                        </a:rPr>
                        <a:t>Δ</a:t>
                      </a:r>
                      <a:r>
                        <a:rPr lang="en-US" sz="900" u="none" strike="noStrike">
                          <a:effectLst/>
                        </a:rPr>
                        <a:t>C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old chan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 valu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3963823645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3165443312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.648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6.58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941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081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4281070381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8.2367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210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973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636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220392682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8.02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.962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934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3083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2676070343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.037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5657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.5283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433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549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495736240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.221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343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5.12193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287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470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8561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3222866072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.071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.446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-0.6256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5428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4212606808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.877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.584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-0.293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253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3179868580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.129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8.9369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-1.1927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8583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3494524687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.110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7.450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-2.660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6.321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805497216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.109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1.3267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2176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42999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2002040462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.78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.263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-0.519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433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180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40.3759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323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3843929253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.3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9.113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-1.193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2867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9193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4.939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1852465831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1913397220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091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879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7880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447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1538840776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0.803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2159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4122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93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415059580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1.013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660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6472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798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3898186270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340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7199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3790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922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241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151883130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1006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5.285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3.1844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099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451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3633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2225391129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285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5.012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7268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51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3227053832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1.687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476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7890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4467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1020284942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538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645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1077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2320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2054881580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097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5.067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9701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276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2224799196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646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5.215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5688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685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1501706826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063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55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4962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772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7079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1.3757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70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3812111124"/>
                  </a:ext>
                </a:extLst>
              </a:tr>
              <a:tr h="1627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-a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2.552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cam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B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4.915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2.36264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1944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0348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>
                          <a:effectLst/>
                        </a:rPr>
                        <a:t>0.2807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137" marR="8137" marT="8137" marB="0" anchor="b"/>
                </a:tc>
                <a:extLst>
                  <a:ext uri="{0D108BD9-81ED-4DB2-BD59-A6C34878D82A}">
                    <a16:rowId xmlns:a16="http://schemas.microsoft.com/office/drawing/2014/main" xmlns="" val="1449246644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133600" y="914400"/>
            <a:ext cx="3092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2</a:t>
            </a:r>
            <a:r>
              <a:rPr lang="en-US" dirty="0" smtClean="0"/>
              <a:t>-figure supplement 1D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5919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540</Words>
  <Application>Microsoft Macintosh PowerPoint</Application>
  <PresentationFormat>On-screen Show (4:3)</PresentationFormat>
  <Paragraphs>44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a</dc:creator>
  <cp:lastModifiedBy>Susanna</cp:lastModifiedBy>
  <cp:revision>9</cp:revision>
  <dcterms:created xsi:type="dcterms:W3CDTF">2018-12-03T10:45:52Z</dcterms:created>
  <dcterms:modified xsi:type="dcterms:W3CDTF">2018-12-03T10:57:24Z</dcterms:modified>
</cp:coreProperties>
</file>